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1/05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1/0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chematic illustration of </a:t>
            </a:r>
            <a:r>
              <a:rPr lang="en-US" sz="2000" b="1" dirty="0" err="1"/>
              <a:t>monoagonists</a:t>
            </a:r>
            <a:r>
              <a:rPr lang="en-US" sz="2000" b="1" dirty="0"/>
              <a:t>, dual agonists and triple agonists based on GLP-1, GIP and glucagon receptor activation</a:t>
            </a:r>
            <a:endParaRPr lang="en-GB" sz="20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ABC00E8-B73D-B74F-A796-C380E0C07F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9631" y="1094911"/>
            <a:ext cx="6647277" cy="49263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F96F1A-3B4A-C479-25A5-EB9B90F108A2}"/>
              </a:ext>
            </a:extLst>
          </p:cNvPr>
          <p:cNvSpPr txBox="1"/>
          <p:nvPr/>
        </p:nvSpPr>
        <p:spPr>
          <a:xfrm>
            <a:off x="107504" y="6021288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chöp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5929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(s) 2023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he clinically most relevant mechanisms of action of GLP-1, glucagon and GIP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31B7F33-BCBD-7D29-7AD9-C00BC1D73F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1800" y="764703"/>
            <a:ext cx="3456384" cy="53758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A31ECED-1C1C-89CE-FB1C-53D52D147F5E}"/>
              </a:ext>
            </a:extLst>
          </p:cNvPr>
          <p:cNvSpPr txBox="1"/>
          <p:nvPr/>
        </p:nvSpPr>
        <p:spPr>
          <a:xfrm>
            <a:off x="107504" y="6021288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chöp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5929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(s) 2023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2ECC202-0164-89E1-AFD7-4BE0AE1B2C4A}"/>
              </a:ext>
            </a:extLst>
          </p:cNvPr>
          <p:cNvGrpSpPr/>
          <p:nvPr/>
        </p:nvGrpSpPr>
        <p:grpSpPr>
          <a:xfrm>
            <a:off x="1619671" y="745438"/>
            <a:ext cx="6259066" cy="5544849"/>
            <a:chOff x="1619671" y="745438"/>
            <a:chExt cx="6259066" cy="5544849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0D390487-B5E9-D9A5-C495-B724C128D7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16890" y="4160015"/>
              <a:ext cx="6061847" cy="2130272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F40D4D3-A0F6-F6FF-7121-A741F65856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9671" y="745438"/>
              <a:ext cx="5688633" cy="3315762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tructures of formulations of GLP-1 receptor agonist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338567"/>
            <a:ext cx="1675152" cy="4748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8BDB6FC-B772-F919-2B35-A1AEC89788B7}"/>
              </a:ext>
            </a:extLst>
          </p:cNvPr>
          <p:cNvSpPr txBox="1"/>
          <p:nvPr/>
        </p:nvSpPr>
        <p:spPr>
          <a:xfrm>
            <a:off x="107504" y="6021288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chöp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5929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(s) 2023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tructures of (a) GLP-1, (b) GIP and (c) </a:t>
            </a:r>
            <a:r>
              <a:rPr lang="en-US" sz="2000" b="1" dirty="0" err="1"/>
              <a:t>tirzepatide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629E4B0-0275-0F2B-E910-D9DC30957D32}"/>
              </a:ext>
            </a:extLst>
          </p:cNvPr>
          <p:cNvSpPr txBox="1"/>
          <p:nvPr/>
        </p:nvSpPr>
        <p:spPr>
          <a:xfrm>
            <a:off x="107504" y="6021288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schöp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5929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(s) 202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5781409-F0AD-CD64-8290-AEBDE087EA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8556" y="991674"/>
            <a:ext cx="5406887" cy="4914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0279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28</Words>
  <Application>Microsoft Office PowerPoint</Application>
  <PresentationFormat>On-screen Show (4:3)</PresentationFormat>
  <Paragraphs>1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4</cp:revision>
  <dcterms:created xsi:type="dcterms:W3CDTF">2016-06-15T12:53:43Z</dcterms:created>
  <dcterms:modified xsi:type="dcterms:W3CDTF">2023-05-11T15:15:08Z</dcterms:modified>
</cp:coreProperties>
</file>